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0" r:id="rId2"/>
    <p:sldId id="262" r:id="rId3"/>
    <p:sldId id="261" r:id="rId4"/>
    <p:sldId id="258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125"/>
    <p:restoredTop sz="85034"/>
  </p:normalViewPr>
  <p:slideViewPr>
    <p:cSldViewPr snapToGrid="0" snapToObjects="1" showGuides="1">
      <p:cViewPr varScale="1">
        <p:scale>
          <a:sx n="103" d="100"/>
          <a:sy n="103" d="100"/>
        </p:scale>
        <p:origin x="1688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0BE3A4-1ACB-DF4A-A2DD-FB064D03BE57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386AED-4883-4D4A-9476-399B1B0D53B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33809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/>
              <a:t>a)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386AED-4883-4D4A-9476-399B1B0D53B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28784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/>
              <a:t>a)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386AED-4883-4D4A-9476-399B1B0D53B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31074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/>
              <a:t>a)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386AED-4883-4D4A-9476-399B1B0D53B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65128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b)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386AED-4883-4D4A-9476-399B1B0D53B5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7361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37F4D05-6944-014F-93BB-0885411912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08705E6-7A44-1A44-B65A-087ED78C32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65F2C29-2F86-7749-A4F2-C05CBB226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B8B8AF-19C3-4642-ABCD-3A726183CB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DCBF3A-4CB4-A84B-B89B-EAB6E82A5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282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4C68A0D-6C5C-1643-8DAF-CEE154157C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A35A55D-E4F1-EF42-B12A-3F591DDFD8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FFA76A-C6B7-334A-AF21-361C870BC9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D81A12-DB42-7040-9E77-52810E5C7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53E618-C5ED-A54E-90D7-AE2D36D335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45050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3A540CF-6217-A549-9987-0FF76DC503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59EB8CA-25BD-5344-B39C-EBE25515EA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820D36-A64D-7845-B857-63136563D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225302E-88D4-7C4A-806E-4094ADD14E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A3FB09-4B0D-124B-992F-D92C0B0DE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82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A53E35-20BC-7E4A-AF06-B6CB4E0A08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AF39A1D-63D3-C148-94FD-CD4E884F15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684B7EF-0414-7D49-AF9F-35EF7846B4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565753-592C-C947-B3C2-D447F190A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59A5CB-6A9E-2745-8064-D45C877C8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9615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D088D0-432F-FA47-AE24-1B9B987DFB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51EE52-2234-A94F-9118-E3CD7D69F0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06D08B-35D2-5645-B5A9-0BBD5F0E0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31F6480-B42E-764C-9263-E05F076FE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954125F-18BE-9145-A0F7-0F46448F88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7602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E8ED37-FA20-A641-B141-9661FB468E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D77FAD8-4225-5647-95D3-F5D554F7AE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166FB57-2DDB-1E47-B5D7-5C5AC3C591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FBF152B-7F4D-8C49-9C33-485152DF8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91C95B7-1959-164C-9E6A-9F4D867BD1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0BC1B36-7EB9-AD46-B600-4B62D6C30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3497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EFDA9BA-0BB1-1D4C-816D-453E371652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38A918E-141F-9F4C-A6FC-638C5E4091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899DDDC-7FD3-D941-8485-57C3B92C57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A74D544-6D4E-5A49-8542-0E77A5B811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EF2FABD-4F0F-9E42-9974-2B709C9D8B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AF86B29-49DE-C943-9E5C-540C6E23C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269E66F-405B-364B-B6EA-433444323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CD9AFEBD-FE32-F44D-8A92-F4768A576B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40354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E184EE-23F6-914B-BFB5-2C0E780308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1B5F1F5-A641-2448-8E3A-727551E36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FDE768F-A3B8-A045-B2F9-1F331D03C5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88EC0CD-18DB-D244-B684-AFDCF0D00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899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7ED92C7-66AB-5849-946B-FEA83241A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1F04C07-FF9E-3D4C-A480-C7D6A9A38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6E11D0D-364F-544E-914E-7808A826A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396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EFE5247-CD0E-7A4C-B6F7-605CFFDB44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C949734-6A93-E04E-896B-38D5B069A8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4C82327-CF0A-D84D-9C99-D848D78627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034E0C5-5021-9A43-B06C-127ADD510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1D2B027-9BB6-AA4E-8B6C-4137CCD32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4E13EF5-F457-3F43-A649-2F853B27D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3359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7D925C-4E3B-3C41-ACC2-86BA7161B9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A260FE7-3398-8349-BAB8-B1CF8914E5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BB59B9B-E164-894C-8849-8EE855BEB2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BD73967-4FDE-E14E-9C04-C85426394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63EC925-4953-774A-B11B-9C398DFEB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917E39A-3AE0-3644-9736-D81B113C6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9131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DE6775C-DCAA-7B40-9689-2524608946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CD5A004-63C6-1949-86DC-6B8A9BD81B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71CE1C-7DC5-7545-95C6-0C397A2069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2C3A7-A509-F944-9A0B-B604A0F65890}" type="datetimeFigureOut">
              <a:rPr kumimoji="1" lang="ja-JP" altLang="en-US" smtClean="0"/>
              <a:t>2021/8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DFFAED-5293-E944-AE0D-251653BB7A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D182FC0-A172-3848-85A4-467E11A5E99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8CDA07-24FE-BE4E-852A-7146892408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5119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6EB965-FC29-8C44-9D05-E830592942CA}"/>
              </a:ext>
            </a:extLst>
          </p:cNvPr>
          <p:cNvSpPr txBox="1"/>
          <p:nvPr/>
        </p:nvSpPr>
        <p:spPr>
          <a:xfrm>
            <a:off x="277906" y="1416424"/>
            <a:ext cx="116361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oncordance Analysis of Microsatellite Instability Status Between Polymerase Chain Reaction based Testing and Next Generation Sequencing Assay for Solid Tumors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230EB3E-EFDC-0B46-9342-6CAFAC6F3E38}"/>
              </a:ext>
            </a:extLst>
          </p:cNvPr>
          <p:cNvSpPr txBox="1"/>
          <p:nvPr/>
        </p:nvSpPr>
        <p:spPr>
          <a:xfrm>
            <a:off x="430306" y="3105834"/>
            <a:ext cx="11636188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Keitaro Shimozaki1 (ORCID 0000-0002-4559-5699), Hideyuki Hayashi2 (ORCID 0000-0002-4974-8015), Shigeki Tanishima3, Sara Horie1, Akihiko Chida1, Kai Tsugaru1, Kazuhiro Togasaki1, Kenta Kawasaki1, Eriko Aimono2, </a:t>
            </a:r>
            <a:r>
              <a:rPr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Kenro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Hirata1, Hiroshi Nishihara2, Takanori Kanai1, Yasuo Hamamoto2</a:t>
            </a:r>
          </a:p>
          <a:p>
            <a:pPr algn="ctr"/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 Division of Gastroenterology and Hepatology, Department of Internal Medicine, Keio University School of Medicine, Tokyo, Japan</a:t>
            </a:r>
          </a:p>
          <a:p>
            <a:pPr algn="ctr"/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2 Keio Cancer Center, Keio University School of Medicine, Tokyo, Japan</a:t>
            </a:r>
          </a:p>
          <a:p>
            <a:pPr algn="ctr"/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3 Department of Biomedical Informatics Development, Mitsubishi Space Software Co., Ltd, Tokyo, Japan</a:t>
            </a:r>
          </a:p>
          <a:p>
            <a:pPr algn="ctr"/>
            <a:endParaRPr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86735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6EB965-FC29-8C44-9D05-E830592942CA}"/>
              </a:ext>
            </a:extLst>
          </p:cNvPr>
          <p:cNvSpPr txBox="1"/>
          <p:nvPr/>
        </p:nvSpPr>
        <p:spPr>
          <a:xfrm>
            <a:off x="277906" y="1416424"/>
            <a:ext cx="116361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. S1 Capillary electropherogram of PCR-based MSI testing in cases 3 a) and 4 b).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84695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6EB965-FC29-8C44-9D05-E830592942CA}"/>
              </a:ext>
            </a:extLst>
          </p:cNvPr>
          <p:cNvSpPr txBox="1"/>
          <p:nvPr/>
        </p:nvSpPr>
        <p:spPr>
          <a:xfrm>
            <a:off x="7339390" y="0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se 3 47-year-old female, pancreatic cancer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467C2ADD-B503-054C-9034-7BE3A497887A}"/>
              </a:ext>
            </a:extLst>
          </p:cNvPr>
          <p:cNvGrpSpPr/>
          <p:nvPr/>
        </p:nvGrpSpPr>
        <p:grpSpPr>
          <a:xfrm>
            <a:off x="2758527" y="458752"/>
            <a:ext cx="6674946" cy="6284948"/>
            <a:chOff x="2472000" y="313226"/>
            <a:chExt cx="6277145" cy="6023622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3B8F1D91-18A2-3B4C-8704-36169A4CF09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72000" y="313226"/>
              <a:ext cx="6277145" cy="2006728"/>
            </a:xfrm>
            <a:prstGeom prst="rect">
              <a:avLst/>
            </a:prstGeom>
          </p:spPr>
        </p:pic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4DF8A68D-A93A-3E43-81D3-1A11A91B2FD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72000" y="2319954"/>
              <a:ext cx="6277145" cy="2000341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2E21BED7-7FD2-384F-97C9-854CDF6B299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472000" y="4326682"/>
              <a:ext cx="6277145" cy="2010166"/>
            </a:xfrm>
            <a:prstGeom prst="rect">
              <a:avLst/>
            </a:prstGeom>
          </p:spPr>
        </p:pic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A737C8A-8205-5F4A-B9C4-6C74FB3E0ED0}"/>
              </a:ext>
            </a:extLst>
          </p:cNvPr>
          <p:cNvSpPr txBox="1"/>
          <p:nvPr/>
        </p:nvSpPr>
        <p:spPr>
          <a:xfrm>
            <a:off x="0" y="0"/>
            <a:ext cx="47115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Shimozaki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K et al.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. S1 a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0911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D6EB965-FC29-8C44-9D05-E830592942CA}"/>
              </a:ext>
            </a:extLst>
          </p:cNvPr>
          <p:cNvSpPr txBox="1"/>
          <p:nvPr/>
        </p:nvSpPr>
        <p:spPr>
          <a:xfrm>
            <a:off x="7339390" y="0"/>
            <a:ext cx="4852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ase 4 78-year-old female, pancreatic cancer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1E59545-6914-B143-9868-73F0FD486D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0464" y="530062"/>
            <a:ext cx="9871071" cy="61343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973CC4B-1232-E64C-B886-5E89CBA59672}"/>
              </a:ext>
            </a:extLst>
          </p:cNvPr>
          <p:cNvSpPr txBox="1"/>
          <p:nvPr/>
        </p:nvSpPr>
        <p:spPr>
          <a:xfrm>
            <a:off x="0" y="0"/>
            <a:ext cx="47115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>
                <a:latin typeface="Arial" panose="020B0604020202020204" pitchFamily="34" charset="0"/>
                <a:cs typeface="Arial" panose="020B0604020202020204" pitchFamily="34" charset="0"/>
              </a:rPr>
              <a:t>Shimozaki</a:t>
            </a: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 K et al.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. S1 b)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33610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</TotalTime>
  <Words>183</Words>
  <Application>Microsoft Macintosh PowerPoint</Application>
  <PresentationFormat>ワイド画面</PresentationFormat>
  <Paragraphs>23</Paragraphs>
  <Slides>4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下嵜啓太郎</dc:creator>
  <cp:lastModifiedBy>下嵜 啓太郎</cp:lastModifiedBy>
  <cp:revision>7</cp:revision>
  <dcterms:created xsi:type="dcterms:W3CDTF">2021-07-19T09:54:46Z</dcterms:created>
  <dcterms:modified xsi:type="dcterms:W3CDTF">2021-08-24T09:25:19Z</dcterms:modified>
</cp:coreProperties>
</file>